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833"/>
  </p:normalViewPr>
  <p:slideViewPr>
    <p:cSldViewPr snapToGrid="0" snapToObjects="1">
      <p:cViewPr varScale="1">
        <p:scale>
          <a:sx n="112" d="100"/>
          <a:sy n="112" d="100"/>
        </p:scale>
        <p:origin x="57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90674D-9CC3-7C44-B5D0-E1B1A896029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48A9E96-EE3B-4740-98F2-E34606AACF7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F825160-0792-D842-A4F0-55D828FBAE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08785-96C3-CE46-8F89-76E6B1099FA2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8F0F7A-D553-E844-85CB-D0C7D78037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EB28C76-2DA5-3E4A-BD0D-66D4B7520D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2694B-D29F-A143-AE6E-2915BD83BB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3854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32E3BF9-1761-4B48-B412-E1A75623C9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0C862BF-78A1-1A42-B94C-D304E497E1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7B38DD6-F6D8-FF41-A43A-A637A4E197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08785-96C3-CE46-8F89-76E6B1099FA2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5ECF6F6-5894-BD48-88DC-B8826D48D0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0DAA8C6-AD61-8348-B0B1-FE24A29611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2694B-D29F-A143-AE6E-2915BD83BB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37489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CF17E48-2D35-B04B-89B1-A65E414CADB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C5C6280-1B14-2245-B292-4406C48A85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53F1728-BF69-0C44-AAEA-74F2736005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08785-96C3-CE46-8F89-76E6B1099FA2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43F4782-D573-984B-92C4-15693A0AB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80BC929-5BC7-F042-96ED-09768524C1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2694B-D29F-A143-AE6E-2915BD83BB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82525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58BE395-7213-DA43-B41C-600DE96E23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9E3A033-FB60-5B49-B395-9C381059EA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D9A58E0-3B5A-8E42-AF9D-288091E31C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08785-96C3-CE46-8F89-76E6B1099FA2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7331D7B-D25F-C742-ACE5-162090CE74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DF04959-2F40-5849-9709-8CD603606F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2694B-D29F-A143-AE6E-2915BD83BB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49828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B7B9F46-DAD7-A749-8F10-56400EDDF2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AA78983-090D-1545-ADB3-0E968249C9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BEEC5DE-F2DC-774A-8B24-90E9DACDBF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08785-96C3-CE46-8F89-76E6B1099FA2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BEFDEB0-0628-6048-BF10-7FEDC16479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EDA0C27-1EF1-9A4D-910E-3DB246FBCA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2694B-D29F-A143-AE6E-2915BD83BB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04866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AA18503-B4DE-DB45-807A-3B7A798216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E7EACAD-CEC6-3640-9246-80AA7F4587D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1E47015-1EAB-104F-8C02-D093316026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4F4AE00-A974-544B-AA84-22FC764865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08785-96C3-CE46-8F89-76E6B1099FA2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14C4A75-687C-4F4D-A28B-D4891EA3F0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A2AC904-5093-1C44-B6FB-2C789A8088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2694B-D29F-A143-AE6E-2915BD83BB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6029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E11701-15C1-844B-A7DC-E41F9B4143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5851CCE-B666-E648-9154-80E39BF9EB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F7BA04E-AE10-F94C-AE94-0E1DE82E96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800549B-C748-4B4D-8682-936CEE3B8D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1ECFAC5-78DB-1442-9141-71AC4C453B2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F673275-449A-1549-8D32-A0592EFD17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08785-96C3-CE46-8F89-76E6B1099FA2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CD2D2DF-6BA0-1347-ADF9-4B6DF33B4C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3DF8C53-B713-814B-896D-D37A62898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2694B-D29F-A143-AE6E-2915BD83BB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78356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AA927EC-731C-634A-8A3C-B6160615DA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2CF8D4A1-5CC1-F04F-B16A-0DEE609E95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08785-96C3-CE46-8F89-76E6B1099FA2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4DFDEC3-DF94-434F-91D9-2ED1CF961D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434009E-CAF5-3A4A-8D4C-C6DCF97962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2694B-D29F-A143-AE6E-2915BD83BB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93759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4213841-F16B-3849-9852-CF26AA0AFB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08785-96C3-CE46-8F89-76E6B1099FA2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BA694AC-B224-EF47-8B84-92F3716D73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43AAC61-6E3F-FD4D-A054-6AE4EEB20A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2694B-D29F-A143-AE6E-2915BD83BB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22198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E728078-8DAA-DF4A-AC15-F03593A180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3B615C2-DFFF-E34E-BDCA-55ABAC30B9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524D538-10EA-1848-A1EB-23B0D5EEA8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F8A6F81-BFB4-4D4B-B885-9166653DF7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08785-96C3-CE46-8F89-76E6B1099FA2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536A9BB-E0A4-094D-93A9-341902DF4F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F5764A5-F18A-9F44-BA2B-A3A55D593C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2694B-D29F-A143-AE6E-2915BD83BB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91488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84317DE-9EED-A647-ABCD-EA8FD691E3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B27D50B-520F-114A-BE49-AB58F720B42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2799D1E-39B6-BD4B-93F5-667EFC0141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7A59B02-2695-A845-B96C-7B4BEC5629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08785-96C3-CE46-8F89-76E6B1099FA2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55031AD-A55E-4345-85BB-CE579B8EE9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F93C1D6-43A7-0B47-808F-5893188B29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2694B-D29F-A143-AE6E-2915BD83BB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84363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76A8F08-9C92-0A44-A175-E8682E2153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6864377-47BD-874C-A485-D669433FA2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F53B4D0-AD0E-444E-8FD4-5FB7FE52378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208785-96C3-CE46-8F89-76E6B1099FA2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0915F02-0101-CF46-BFD6-C963AE1647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469BBF6-267F-CF40-A273-57A1AF0A27C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72694B-D29F-A143-AE6E-2915BD83BB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34687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CA13D301-7A11-2C46-B5D6-CCA046706C18}"/>
              </a:ext>
            </a:extLst>
          </p:cNvPr>
          <p:cNvSpPr/>
          <p:nvPr/>
        </p:nvSpPr>
        <p:spPr>
          <a:xfrm>
            <a:off x="2650572" y="310632"/>
            <a:ext cx="768096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b="1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upp. Fig 1</a:t>
            </a:r>
            <a:r>
              <a:rPr lang="en-US" altLang="ja-JP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Comparison of antibody acquisition rates by vaccine type</a:t>
            </a:r>
            <a:endParaRPr lang="ja-JP" altLang="ja-JP" sz="2800" dirty="0"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4FD4D6C7-E8C6-4D66-B879-9C7A7D42ED69}"/>
              </a:ext>
            </a:extLst>
          </p:cNvPr>
          <p:cNvSpPr txBox="1"/>
          <p:nvPr/>
        </p:nvSpPr>
        <p:spPr>
          <a:xfrm rot="16200000">
            <a:off x="1492537" y="3348291"/>
            <a:ext cx="2951193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419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RS-CoV2 spike-IgG Ab (AU/mL)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3B2B9638-9CEC-694B-9249-D4C774D7DD25}"/>
              </a:ext>
            </a:extLst>
          </p:cNvPr>
          <p:cNvGrpSpPr/>
          <p:nvPr/>
        </p:nvGrpSpPr>
        <p:grpSpPr>
          <a:xfrm>
            <a:off x="3143810" y="1323421"/>
            <a:ext cx="6045477" cy="4514307"/>
            <a:chOff x="1619809" y="1323420"/>
            <a:chExt cx="6045477" cy="4514307"/>
          </a:xfrm>
        </p:grpSpPr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55DCB671-D445-4B6E-974C-6164A52CD8B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59938" y="1580523"/>
              <a:ext cx="4139261" cy="4131177"/>
            </a:xfrm>
            <a:prstGeom prst="rect">
              <a:avLst/>
            </a:prstGeom>
          </p:spPr>
        </p:pic>
        <p:sp>
          <p:nvSpPr>
            <p:cNvPr id="2" name="正方形/長方形 1">
              <a:extLst>
                <a:ext uri="{FF2B5EF4-FFF2-40B4-BE49-F238E27FC236}">
                  <a16:creationId xmlns:a16="http://schemas.microsoft.com/office/drawing/2014/main" id="{677CAFFE-4817-4CF5-AD76-F91A8581D597}"/>
                </a:ext>
              </a:extLst>
            </p:cNvPr>
            <p:cNvSpPr/>
            <p:nvPr/>
          </p:nvSpPr>
          <p:spPr>
            <a:xfrm>
              <a:off x="2633488" y="5395324"/>
              <a:ext cx="1825309" cy="3520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4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NT162b2</a:t>
              </a:r>
              <a:endParaRPr lang="ja-JP" alt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DED7831A-33F1-4C2A-BB1A-26314C27B939}"/>
                </a:ext>
              </a:extLst>
            </p:cNvPr>
            <p:cNvSpPr/>
            <p:nvPr/>
          </p:nvSpPr>
          <p:spPr>
            <a:xfrm>
              <a:off x="4224015" y="5418795"/>
              <a:ext cx="2300739" cy="29489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4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RNA-1273</a:t>
              </a:r>
              <a:endParaRPr lang="ja-JP" alt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id="{DC49698F-3C65-430C-965A-179F37401BF5}"/>
                </a:ext>
              </a:extLst>
            </p:cNvPr>
            <p:cNvSpPr/>
            <p:nvPr/>
          </p:nvSpPr>
          <p:spPr>
            <a:xfrm>
              <a:off x="2138626" y="1780734"/>
              <a:ext cx="304800" cy="405699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solidFill>
                  <a:schemeClr val="tx1"/>
                </a:solidFill>
              </a:endParaRPr>
            </a:p>
          </p:txBody>
        </p:sp>
        <p:cxnSp>
          <p:nvCxnSpPr>
            <p:cNvPr id="40" name="直線コネクタ 39">
              <a:extLst>
                <a:ext uri="{FF2B5EF4-FFF2-40B4-BE49-F238E27FC236}">
                  <a16:creationId xmlns:a16="http://schemas.microsoft.com/office/drawing/2014/main" id="{D2FBBE7A-C11C-4EA2-A7FC-A8FEFB744A1A}"/>
                </a:ext>
              </a:extLst>
            </p:cNvPr>
            <p:cNvCxnSpPr>
              <a:cxnSpLocks/>
            </p:cNvCxnSpPr>
            <p:nvPr/>
          </p:nvCxnSpPr>
          <p:spPr>
            <a:xfrm>
              <a:off x="2063498" y="3537132"/>
              <a:ext cx="4629993" cy="0"/>
            </a:xfrm>
            <a:prstGeom prst="line">
              <a:avLst/>
            </a:prstGeom>
            <a:ln w="6350"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C34458B9-44A1-45F7-9EDC-2128C7C3955E}"/>
                </a:ext>
              </a:extLst>
            </p:cNvPr>
            <p:cNvSpPr/>
            <p:nvPr/>
          </p:nvSpPr>
          <p:spPr>
            <a:xfrm>
              <a:off x="1829383" y="1406132"/>
              <a:ext cx="4667528" cy="27823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dirty="0"/>
            </a:p>
          </p:txBody>
        </p:sp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FC2316DA-7BC7-49CA-ABD3-004BACDA38F9}"/>
                </a:ext>
              </a:extLst>
            </p:cNvPr>
            <p:cNvSpPr/>
            <p:nvPr/>
          </p:nvSpPr>
          <p:spPr>
            <a:xfrm flipV="1">
              <a:off x="6164297" y="1675661"/>
              <a:ext cx="449019" cy="366871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dirty="0"/>
            </a:p>
          </p:txBody>
        </p:sp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id="{A6C3FEFA-C3F3-491E-BF1E-DB91EABB945E}"/>
                </a:ext>
              </a:extLst>
            </p:cNvPr>
            <p:cNvSpPr/>
            <p:nvPr/>
          </p:nvSpPr>
          <p:spPr>
            <a:xfrm>
              <a:off x="6093394" y="3327065"/>
              <a:ext cx="1571892" cy="40646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4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ut off value: 50</a:t>
              </a:r>
              <a:endParaRPr lang="ja-JP" alt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3F1BE77C-B7B7-9F4A-AD80-B6CE4CFF6CA9}"/>
                </a:ext>
              </a:extLst>
            </p:cNvPr>
            <p:cNvSpPr txBox="1"/>
            <p:nvPr/>
          </p:nvSpPr>
          <p:spPr>
            <a:xfrm>
              <a:off x="1619809" y="1946433"/>
              <a:ext cx="67839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,000.0</a:t>
              </a:r>
              <a:endParaRPr lang="ja-JP" altLang="en-US" sz="11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3DC61D9D-4ED0-EC45-9EAF-D23AFDF5E390}"/>
                </a:ext>
              </a:extLst>
            </p:cNvPr>
            <p:cNvSpPr txBox="1"/>
            <p:nvPr/>
          </p:nvSpPr>
          <p:spPr>
            <a:xfrm>
              <a:off x="1690341" y="2506449"/>
              <a:ext cx="6078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,000.0</a:t>
              </a:r>
              <a:endParaRPr lang="ja-JP" altLang="en-US" sz="11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93F247DE-4A27-9B4B-ACED-B5C41FEC0171}"/>
                </a:ext>
              </a:extLst>
            </p:cNvPr>
            <p:cNvSpPr txBox="1"/>
            <p:nvPr/>
          </p:nvSpPr>
          <p:spPr>
            <a:xfrm>
              <a:off x="1796139" y="3157501"/>
              <a:ext cx="50206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.0</a:t>
              </a:r>
              <a:endParaRPr lang="ja-JP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688698EC-BE54-5342-BB17-C7AD1EB30E88}"/>
                </a:ext>
              </a:extLst>
            </p:cNvPr>
            <p:cNvSpPr txBox="1"/>
            <p:nvPr/>
          </p:nvSpPr>
          <p:spPr>
            <a:xfrm>
              <a:off x="1866672" y="3808553"/>
              <a:ext cx="43152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.0</a:t>
              </a:r>
              <a:endParaRPr lang="ja-JP" altLang="en-US" sz="11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C777600F-46B1-7142-9B12-030B7E34B7B2}"/>
                </a:ext>
              </a:extLst>
            </p:cNvPr>
            <p:cNvSpPr txBox="1"/>
            <p:nvPr/>
          </p:nvSpPr>
          <p:spPr>
            <a:xfrm>
              <a:off x="1937204" y="4410177"/>
              <a:ext cx="3609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lang="ja-JP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8543EC21-CD20-C44E-ACF1-C90A4D7A4282}"/>
                </a:ext>
              </a:extLst>
            </p:cNvPr>
            <p:cNvSpPr txBox="1"/>
            <p:nvPr/>
          </p:nvSpPr>
          <p:spPr>
            <a:xfrm>
              <a:off x="2043002" y="5048874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F01A21A5-A343-4EA1-BF36-F488E822B134}"/>
                </a:ext>
              </a:extLst>
            </p:cNvPr>
            <p:cNvCxnSpPr>
              <a:cxnSpLocks/>
            </p:cNvCxnSpPr>
            <p:nvPr/>
          </p:nvCxnSpPr>
          <p:spPr>
            <a:xfrm>
              <a:off x="3277823" y="1631195"/>
              <a:ext cx="199851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A6FCC658-54FE-4901-910D-B678A3FD1422}"/>
                </a:ext>
              </a:extLst>
            </p:cNvPr>
            <p:cNvSpPr txBox="1"/>
            <p:nvPr/>
          </p:nvSpPr>
          <p:spPr>
            <a:xfrm>
              <a:off x="3871867" y="1323420"/>
              <a:ext cx="810424" cy="30777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 = 0.01</a:t>
              </a:r>
              <a:endPara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945057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</Words>
  <Application>Microsoft Macintosh PowerPoint</Application>
  <PresentationFormat>ワイド画面</PresentationFormat>
  <Paragraphs>1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藤枝 久美子</dc:creator>
  <cp:lastModifiedBy>藤枝 久美子</cp:lastModifiedBy>
  <cp:revision>1</cp:revision>
  <dcterms:created xsi:type="dcterms:W3CDTF">2022-01-14T01:37:53Z</dcterms:created>
  <dcterms:modified xsi:type="dcterms:W3CDTF">2022-01-14T01:38:36Z</dcterms:modified>
</cp:coreProperties>
</file>